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1107" r:id="rId3"/>
    <p:sldId id="1253" r:id="rId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58"/>
  </p:normalViewPr>
  <p:slideViewPr>
    <p:cSldViewPr snapToGrid="0">
      <p:cViewPr varScale="1">
        <p:scale>
          <a:sx n="116" d="100"/>
          <a:sy n="116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gizquierdo\Desktop\SLIPE%202023\Grafico%20tendencia%20prevalencia%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8379598992558941E-2"/>
          <c:y val="1.7674913354790028E-2"/>
          <c:w val="0.90562548776329443"/>
          <c:h val="0.661713231340556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C$4</c:f>
              <c:strCache>
                <c:ptCount val="1"/>
                <c:pt idx="0">
                  <c:v>N° of  cCMV cases /Month</c:v>
                </c:pt>
              </c:strCache>
            </c:strRef>
          </c:tx>
          <c:spPr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1!$B$5:$B$16</c:f>
              <c:strCache>
                <c:ptCount val="12"/>
                <c:pt idx="0">
                  <c:v>September</c:v>
                </c:pt>
                <c:pt idx="1">
                  <c:v>October</c:v>
                </c:pt>
                <c:pt idx="2">
                  <c:v>November</c:v>
                </c:pt>
                <c:pt idx="3">
                  <c:v>December</c:v>
                </c:pt>
                <c:pt idx="4">
                  <c:v>January</c:v>
                </c:pt>
                <c:pt idx="5">
                  <c:v>February</c:v>
                </c:pt>
                <c:pt idx="6">
                  <c:v>March</c:v>
                </c:pt>
                <c:pt idx="7">
                  <c:v>April</c:v>
                </c:pt>
                <c:pt idx="8">
                  <c:v>May</c:v>
                </c:pt>
                <c:pt idx="9">
                  <c:v>June</c:v>
                </c:pt>
                <c:pt idx="10">
                  <c:v>July</c:v>
                </c:pt>
                <c:pt idx="11">
                  <c:v>August</c:v>
                </c:pt>
              </c:strCache>
            </c:strRef>
          </c:cat>
          <c:val>
            <c:numRef>
              <c:f>Hoja1!$C$5:$C$16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3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6C-CD45-AC7C-7C2194C9F7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486276800"/>
        <c:axId val="486278528"/>
      </c:barChart>
      <c:lineChart>
        <c:grouping val="standard"/>
        <c:varyColors val="0"/>
        <c:ser>
          <c:idx val="1"/>
          <c:order val="1"/>
          <c:tx>
            <c:strRef>
              <c:f>Hoja1!$D$4</c:f>
              <c:strCache>
                <c:ptCount val="1"/>
                <c:pt idx="0">
                  <c:v>Cumulative cCMV prevalence</c:v>
                </c:pt>
              </c:strCache>
            </c:strRef>
          </c:tx>
          <c:spPr>
            <a:ln w="2222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dLbls>
            <c:dLbl>
              <c:idx val="8"/>
              <c:layout>
                <c:manualLayout>
                  <c:x val="-2.7455169692341855E-2"/>
                  <c:y val="-4.2158647350032788E-2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A6C-CD45-AC7C-7C2194C9F734}"/>
                </c:ext>
              </c:extLst>
            </c:dLbl>
            <c:spPr>
              <a:solidFill>
                <a:schemeClr val="bg2"/>
              </a:solidFill>
              <a:ln>
                <a:solidFill>
                  <a:schemeClr val="dk1"/>
                </a:solidFill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s-CL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Hoja1!$B$5:$B$12</c:f>
              <c:strCache>
                <c:ptCount val="8"/>
                <c:pt idx="0">
                  <c:v>September</c:v>
                </c:pt>
                <c:pt idx="1">
                  <c:v>October</c:v>
                </c:pt>
                <c:pt idx="2">
                  <c:v>November</c:v>
                </c:pt>
                <c:pt idx="3">
                  <c:v>December</c:v>
                </c:pt>
                <c:pt idx="4">
                  <c:v>January</c:v>
                </c:pt>
                <c:pt idx="5">
                  <c:v>February</c:v>
                </c:pt>
                <c:pt idx="6">
                  <c:v>March</c:v>
                </c:pt>
                <c:pt idx="7">
                  <c:v>April</c:v>
                </c:pt>
              </c:strCache>
            </c:strRef>
          </c:cat>
          <c:val>
            <c:numRef>
              <c:f>Hoja1!$D$5:$D$16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 formatCode="0.00">
                  <c:v>0.12345679012345678</c:v>
                </c:pt>
                <c:pt idx="5" formatCode="0.00">
                  <c:v>0.27985074626865669</c:v>
                </c:pt>
                <c:pt idx="6" formatCode="0.00">
                  <c:v>0.32154340836012862</c:v>
                </c:pt>
                <c:pt idx="7" formatCode="0.00">
                  <c:v>0.39708802117802777</c:v>
                </c:pt>
                <c:pt idx="8" formatCode="0.00">
                  <c:v>0.53763440860215062</c:v>
                </c:pt>
                <c:pt idx="9" formatCode="0.00">
                  <c:v>0.48727666486193827</c:v>
                </c:pt>
                <c:pt idx="10" formatCode="0.00">
                  <c:v>0.44226044226044231</c:v>
                </c:pt>
                <c:pt idx="11" formatCode="0.00">
                  <c:v>0.457456541628545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A6C-CD45-AC7C-7C2194C9F7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2914592"/>
        <c:axId val="874212576"/>
      </c:lineChart>
      <c:catAx>
        <c:axId val="486276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s-CL"/>
          </a:p>
        </c:txPr>
        <c:crossAx val="486278528"/>
        <c:crosses val="autoZero"/>
        <c:auto val="1"/>
        <c:lblAlgn val="ctr"/>
        <c:lblOffset val="100"/>
        <c:noMultiLvlLbl val="0"/>
      </c:catAx>
      <c:valAx>
        <c:axId val="486278528"/>
        <c:scaling>
          <c:orientation val="minMax"/>
          <c:max val="4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L"/>
          </a:p>
        </c:txPr>
        <c:crossAx val="486276800"/>
        <c:crosses val="autoZero"/>
        <c:crossBetween val="between"/>
        <c:majorUnit val="1"/>
      </c:valAx>
      <c:valAx>
        <c:axId val="874212576"/>
        <c:scaling>
          <c:orientation val="minMax"/>
          <c:max val="1"/>
        </c:scaling>
        <c:delete val="0"/>
        <c:axPos val="r"/>
        <c:numFmt formatCode="General" sourceLinked="1"/>
        <c:majorTickMark val="none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L"/>
          </a:p>
        </c:txPr>
        <c:crossAx val="522914592"/>
        <c:crosses val="max"/>
        <c:crossBetween val="between"/>
      </c:valAx>
      <c:catAx>
        <c:axId val="5229145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742125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072515688733899"/>
          <c:y val="0.85991856772439323"/>
          <c:w val="0.62626989944960543"/>
          <c:h val="4.76947649365953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s-CL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C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6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dk1">
            <a:lumMod val="75000"/>
            <a:lumOff val="2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dk1">
            <a:lumMod val="75000"/>
            <a:lumOff val="25000"/>
          </a:schemeClr>
        </a:solidFill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04AAB1-A5B4-9B0B-CB97-A4D5448917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BEEDBB3-ACBA-E98B-8FE5-258061F93A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MX"/>
              <a:t>Haz clic para edit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0602C9C-9CD8-9CB0-BDF3-C22FF8C4D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B6A757D-5408-3853-3B97-CCCDABF1E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E86E738-155E-1D9F-180E-E57ADBEC4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59924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140293-C92D-9420-F16C-A132B64CB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1227258-5C16-3D0E-745C-0E6C944B4B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E635581-DDE8-C540-56EB-EF701EBA9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BD40414-1223-9D0E-7E35-C6FB6C801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3EFC2EE-C238-48F4-CBA7-7AF3E1FE1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8448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4CC797D-CA29-260E-588D-3C85B0EA52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034C827-7894-98A1-EE7B-08A21FDAD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62B2191-8D60-70F6-4861-C15503417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C18C6A8-F6FA-4876-055E-E377066E1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F5298E3-97E3-96A2-C1F8-42E7A7094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00574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487E61-8EF3-827C-60A9-608A74AE72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16DA09F-C340-CBB4-2CFB-6632D1045B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EE767D1-0853-A439-BDF8-3A6F6AABD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AEA2B75-0FF2-D0A6-9CBE-EFB0AE5C5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E7614D-EE52-757C-7BA7-62ADA6799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7239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674630-572E-BFFD-32A5-DB0829281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54AF6FB-C727-C588-A31B-6F9C0E00E1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F32EC69-0C57-72EA-E407-3194ABD11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E2424B9-E17C-A096-804F-0E1AA8419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26CC774-804F-BF57-CFE9-659571B82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69906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93C910-332A-3D9E-1810-51A1461598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52A4D69-37E8-9FB5-E933-92BA011D5E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B5A66A1-195C-4961-7C2A-E68B3278F8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82B6109-83E3-9A59-A2FC-E5696778B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7E2B981-E529-FE8C-AB4D-5319249E0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77846FB-9F23-F5A9-9F73-0B56970F1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89028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8558C27-A279-2C21-F3EF-8225654D4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F549908-38E8-BA05-FC6B-2725BE5194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1CC962B-FF9B-D20E-1946-FF75D4BB7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9621D2D-FAB2-D6CD-F82C-6244A8AEEC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4134A08-4DC5-2FAB-482C-70C4CEC55D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FE9D47D-0C8D-0C91-D1CF-7139070D9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9D38602B-1FA0-7D42-E73C-9FD0A745E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7E5DB85-4A70-E2B4-3958-1B6EB0C0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01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EC91069-2EEF-79AF-9E8C-72D4AA3D6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D79DA7E-2768-68CA-CE22-408482A8C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8313800-5C38-B608-C171-EB8CE72A4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7B40537-FE37-4632-67C0-A29853A97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81367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D845802-2495-44FA-A532-F421FF237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EBAA446-414F-837A-38E8-01AF6CF29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5033A38-E857-0076-CAD7-9617FD809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51242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3C8F29-9E8F-8D5E-8278-C9D3F6420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BD83041-A970-787E-E700-E9FB89D141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A973DD4-63F6-A92B-572C-9917FFF460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26FFDB9-C46F-205C-FAEE-7D4ECB675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DF1049C-30D2-7F52-47A6-39C8B58A9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AEB862A-564B-6346-15D6-FE5224EF5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0813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1BA862-20A5-0B29-6509-D8530BF7D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BBD1687-A261-FAF4-48FB-1327291580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232B9EB-F28F-82D5-4BD5-EE1E91F772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MX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0AEE895-DC0A-E423-BE3D-C32270431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B098B30-41BF-CAA6-A68B-7B696087D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9E225BB-EDF1-BD5B-8B9B-EF04EEDFD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23626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B6A160A-0436-9B8D-9912-CAF732D7BB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MX"/>
              <a:t>Haz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E483EB5-AF60-E685-44E0-5740363B7B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MX"/>
              <a:t>Haga clic para modificar los estilos de texto del patrón</a:t>
            </a:r>
          </a:p>
          <a:p>
            <a:pPr lvl="1"/>
            <a:r>
              <a:rPr lang="es-MX"/>
              <a:t>Segundo nivel</a:t>
            </a:r>
          </a:p>
          <a:p>
            <a:pPr lvl="2"/>
            <a:r>
              <a:rPr lang="es-MX"/>
              <a:t>Tercer nivel</a:t>
            </a:r>
          </a:p>
          <a:p>
            <a:pPr lvl="3"/>
            <a:r>
              <a:rPr lang="es-MX"/>
              <a:t>Cuarto nivel</a:t>
            </a:r>
          </a:p>
          <a:p>
            <a:pPr lvl="4"/>
            <a:r>
              <a:rPr lang="es-MX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1944432-925B-5EB9-E022-2002F440D9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E196EC-8ECB-844B-83DA-71445C0F4476}" type="datetimeFigureOut">
              <a:rPr lang="es-CL" smtClean="0"/>
              <a:t>11-05-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E1CDD2E-869E-7702-5E23-95A70FF12E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C11D0BA-11FC-B776-BFA2-7B34E01CEB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C14983-6CC1-7C4C-B617-2034E924C6C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49090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58E74DA-D5D4-A7F0-C7D7-03D563C3F64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aterial 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67D8D5B-07A5-9D1B-6938-8C3FE8C1EAB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s-CL" dirty="0"/>
              <a:t>cCMV </a:t>
            </a:r>
          </a:p>
        </p:txBody>
      </p:sp>
    </p:spTree>
    <p:extLst>
      <p:ext uri="{BB962C8B-B14F-4D97-AF65-F5344CB8AC3E}">
        <p14:creationId xmlns:p14="http://schemas.microsoft.com/office/powerpoint/2010/main" val="14586541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áfico 2">
            <a:extLst>
              <a:ext uri="{FF2B5EF4-FFF2-40B4-BE49-F238E27FC236}">
                <a16:creationId xmlns:a16="http://schemas.microsoft.com/office/drawing/2014/main" id="{E91A6C56-820F-5237-8DF0-1AAF7ABD89C0}"/>
              </a:ext>
            </a:extLst>
          </p:cNvPr>
          <p:cNvGraphicFramePr>
            <a:graphicFrameLocks/>
          </p:cNvGraphicFramePr>
          <p:nvPr/>
        </p:nvGraphicFramePr>
        <p:xfrm>
          <a:off x="1103650" y="1358808"/>
          <a:ext cx="9870140" cy="574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CuadroTexto 4">
            <a:extLst>
              <a:ext uri="{FF2B5EF4-FFF2-40B4-BE49-F238E27FC236}">
                <a16:creationId xmlns:a16="http://schemas.microsoft.com/office/drawing/2014/main" id="{C4157F3D-53DB-D3D9-4B9A-964F65E53731}"/>
              </a:ext>
            </a:extLst>
          </p:cNvPr>
          <p:cNvSpPr txBox="1"/>
          <p:nvPr/>
        </p:nvSpPr>
        <p:spPr>
          <a:xfrm>
            <a:off x="1932142" y="3429000"/>
            <a:ext cx="1687358" cy="1035424"/>
          </a:xfrm>
          <a:prstGeom prst="rect">
            <a:avLst/>
          </a:prstGeom>
          <a:solidFill>
            <a:schemeClr val="lt1"/>
          </a:solidFill>
          <a:ln w="9525" cmpd="sng">
            <a:solidFill>
              <a:schemeClr val="tx1"/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MX" sz="12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MX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Discontinuation of mandatory facemask use due to SASRS-CoV-2</a:t>
            </a:r>
          </a:p>
        </p:txBody>
      </p:sp>
      <p:sp>
        <p:nvSpPr>
          <p:cNvPr id="10" name="Flecha abajo 9">
            <a:extLst>
              <a:ext uri="{FF2B5EF4-FFF2-40B4-BE49-F238E27FC236}">
                <a16:creationId xmlns:a16="http://schemas.microsoft.com/office/drawing/2014/main" id="{7DC8DF24-8CD8-B548-E553-36DDBC251CB1}"/>
              </a:ext>
            </a:extLst>
          </p:cNvPr>
          <p:cNvSpPr/>
          <p:nvPr/>
        </p:nvSpPr>
        <p:spPr>
          <a:xfrm>
            <a:off x="2581836" y="4464424"/>
            <a:ext cx="188258" cy="403411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F442A75B-4043-AD41-12F4-C7EA62A4E3CE}"/>
              </a:ext>
            </a:extLst>
          </p:cNvPr>
          <p:cNvSpPr txBox="1"/>
          <p:nvPr/>
        </p:nvSpPr>
        <p:spPr>
          <a:xfrm>
            <a:off x="1027994" y="219158"/>
            <a:ext cx="1004640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 Figure S</a:t>
            </a:r>
            <a:r>
              <a:rPr lang="en-US" sz="16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1. Monthly distribution of infants diagnosed with cCMV with universal screening strategy with saliva pools - September 2022 – August 2023 </a:t>
            </a:r>
            <a:endParaRPr lang="en-US" sz="16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BBB6C022-A094-1C9B-3556-BB30465FA253}"/>
              </a:ext>
            </a:extLst>
          </p:cNvPr>
          <p:cNvSpPr txBox="1"/>
          <p:nvPr/>
        </p:nvSpPr>
        <p:spPr>
          <a:xfrm>
            <a:off x="10521108" y="87630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E256ED4F-47B4-E0BF-5B06-0DAB7D24396F}"/>
              </a:ext>
            </a:extLst>
          </p:cNvPr>
          <p:cNvSpPr txBox="1"/>
          <p:nvPr/>
        </p:nvSpPr>
        <p:spPr>
          <a:xfrm>
            <a:off x="1433850" y="81280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</p:spTree>
    <p:extLst>
      <p:ext uri="{BB962C8B-B14F-4D97-AF65-F5344CB8AC3E}">
        <p14:creationId xmlns:p14="http://schemas.microsoft.com/office/powerpoint/2010/main" val="3899115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FF5682-9D4E-BFE8-5325-4800B891B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55677" y="5245998"/>
            <a:ext cx="10515600" cy="1325563"/>
          </a:xfrm>
        </p:spPr>
        <p:txBody>
          <a:bodyPr>
            <a:normAutofit/>
          </a:bodyPr>
          <a:lstStyle/>
          <a:p>
            <a:r>
              <a:rPr lang="en-US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>
                <a:latin typeface="Palatino Linotype" panose="0204050205050503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600" dirty="0">
                <a:effectLst/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</a:t>
            </a:r>
            <a:r>
              <a:rPr lang="en-US" sz="1600" b="0" i="0" u="none" strike="noStrike" dirty="0">
                <a:effectLst/>
                <a:latin typeface="Palatino Linotype" panose="02040502050505030304" pitchFamily="18" charset="0"/>
              </a:rPr>
              <a:t>orrelation between whole blood CMV </a:t>
            </a:r>
            <a:r>
              <a:rPr lang="en-US" sz="1600" dirty="0">
                <a:latin typeface="Palatino Linotype" panose="02040502050505030304" pitchFamily="18" charset="0"/>
              </a:rPr>
              <a:t>v</a:t>
            </a:r>
            <a:r>
              <a:rPr lang="en-US" sz="1600" b="0" i="0" u="none" strike="noStrike" dirty="0">
                <a:effectLst/>
                <a:latin typeface="Palatino Linotype" panose="02040502050505030304" pitchFamily="18" charset="0"/>
              </a:rPr>
              <a:t>iral load and the gamma-</a:t>
            </a:r>
            <a:r>
              <a:rPr lang="en-US" sz="1600" b="0" i="0" u="none" strike="noStrike" dirty="0" err="1">
                <a:effectLst/>
                <a:latin typeface="Palatino Linotype" panose="02040502050505030304" pitchFamily="18" charset="0"/>
              </a:rPr>
              <a:t>glutamyltransferase</a:t>
            </a:r>
            <a:r>
              <a:rPr lang="en-US" sz="1600" b="0" i="0" u="none" strike="noStrike" dirty="0">
                <a:effectLst/>
                <a:latin typeface="Palatino Linotype" panose="02040502050505030304" pitchFamily="18" charset="0"/>
              </a:rPr>
              <a:t> (GGT) levels  in the cCMV  infected infants.</a:t>
            </a:r>
            <a:br>
              <a:rPr lang="en-US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</a:br>
            <a:endParaRPr lang="en-US" sz="1600" dirty="0">
              <a:latin typeface="Palatino Linotype" panose="02040502050505030304" pitchFamily="18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AFC5293C-7EB9-9B89-F8B2-FC4220B035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5850" y="401637"/>
            <a:ext cx="7480300" cy="5130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611170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63</Words>
  <Application>Microsoft Macintosh PowerPoint</Application>
  <PresentationFormat>Panorámica</PresentationFormat>
  <Paragraphs>9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Palatino Linotype</vt:lpstr>
      <vt:lpstr>Times New Roman</vt:lpstr>
      <vt:lpstr>Tema de Office</vt:lpstr>
      <vt:lpstr>Supplementary material </vt:lpstr>
      <vt:lpstr>Presentación de PowerPoint</vt:lpstr>
      <vt:lpstr>Supplementary Figure S2. Correlation between whole blood CMV viral load and the gamma-glutamyltransferase (GGT) levels  in the cCMV  infected infant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 </dc:title>
  <dc:creator>Giannina Izquierdo</dc:creator>
  <cp:lastModifiedBy>Giannina Izquierdo</cp:lastModifiedBy>
  <cp:revision>2</cp:revision>
  <dcterms:created xsi:type="dcterms:W3CDTF">2024-04-11T22:19:05Z</dcterms:created>
  <dcterms:modified xsi:type="dcterms:W3CDTF">2024-05-11T13:54:26Z</dcterms:modified>
</cp:coreProperties>
</file>